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846" r:id="rId2"/>
    <p:sldId id="847" r:id="rId3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E28C436-9DC6-ACE1-0DEE-8F48403715CA}" name="Islam, Rafiqul (NIH/NCI) [E]" initials="IR([" userId="S::islams2@nih.gov::f5e29a92-aa12-430f-8b10-24b4249a5435" providerId="AD"/>
  <p188:author id="{130490E7-C091-57DA-DA20-B935654BF42E}" name="Tak Maeda" initials="TM" userId="S::tmaeda@lyell.com::e1039f30-9f51-4f9a-8ef7-fa1005af31c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eda, Takuya (NIH/NCI) [F]" initials="MT([" lastIdx="30" clrIdx="0">
    <p:extLst>
      <p:ext uri="{19B8F6BF-5375-455C-9EA6-DF929625EA0E}">
        <p15:presenceInfo xmlns:p15="http://schemas.microsoft.com/office/powerpoint/2012/main" userId="S::maedat2@nih.gov::cb579246-00ef-4bc6-9ab3-82831aa6f9fd" providerId="AD"/>
      </p:ext>
    </p:extLst>
  </p:cmAuthor>
  <p:cmAuthor id="2" name="Islam, Rafiqul (NIH/NCI) [F]" initials="IR([" lastIdx="27" clrIdx="1">
    <p:extLst>
      <p:ext uri="{19B8F6BF-5375-455C-9EA6-DF929625EA0E}">
        <p15:presenceInfo xmlns:p15="http://schemas.microsoft.com/office/powerpoint/2012/main" userId="S::islams2@nih.gov::f5e29a92-aa12-430f-8b10-24b4249a5435" providerId="AD"/>
      </p:ext>
    </p:extLst>
  </p:cmAuthor>
  <p:cmAuthor id="3" name="Tak Maeda" initials="TM" lastIdx="5" clrIdx="2">
    <p:extLst>
      <p:ext uri="{19B8F6BF-5375-455C-9EA6-DF929625EA0E}">
        <p15:presenceInfo xmlns:p15="http://schemas.microsoft.com/office/powerpoint/2012/main" userId="S::tmaeda@lyell.com::e1039f30-9f51-4f9a-8ef7-fa1005af31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99"/>
    <a:srgbClr val="10AC39"/>
    <a:srgbClr val="FF0066"/>
    <a:srgbClr val="0000CC"/>
    <a:srgbClr val="00FF99"/>
    <a:srgbClr val="003366"/>
    <a:srgbClr val="12C441"/>
    <a:srgbClr val="0F9D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61" autoAdjust="0"/>
    <p:restoredTop sz="96374" autoAdjust="0"/>
  </p:normalViewPr>
  <p:slideViewPr>
    <p:cSldViewPr>
      <p:cViewPr varScale="1">
        <p:scale>
          <a:sx n="94" d="100"/>
          <a:sy n="94" d="100"/>
        </p:scale>
        <p:origin x="3082" y="8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8/10/relationships/authors" Target="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F238DEBA-3D7B-430D-B307-636BB38BEBD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0AE5C62-6D89-413F-9810-CCAD3B9CBC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9076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l">
              <a:defRPr sz="1200"/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/>
          <a:lstStyle>
            <a:lvl1pPr algn="r">
              <a:defRPr sz="1200"/>
            </a:lvl1pPr>
          </a:lstStyle>
          <a:p>
            <a:fld id="{87F1AAE2-27E9-49BE-B73F-CF03F2C3197F}" type="datetimeFigureOut">
              <a:rPr lang="en-US" smtClean="0"/>
              <a:pPr/>
              <a:t>4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8" tIns="46579" rIns="93158" bIns="465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1"/>
            <a:ext cx="5608320" cy="4183380"/>
          </a:xfrm>
          <a:prstGeom prst="rect">
            <a:avLst/>
          </a:prstGeom>
        </p:spPr>
        <p:txBody>
          <a:bodyPr vert="horz" lIns="93158" tIns="46579" rIns="93158" bIns="4657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4820"/>
          </a:xfrm>
          <a:prstGeom prst="rect">
            <a:avLst/>
          </a:prstGeom>
        </p:spPr>
        <p:txBody>
          <a:bodyPr vert="horz" lIns="93158" tIns="46579" rIns="93158" bIns="46579" rtlCol="0" anchor="b"/>
          <a:lstStyle>
            <a:lvl1pPr algn="r">
              <a:defRPr sz="1200"/>
            </a:lvl1pPr>
          </a:lstStyle>
          <a:p>
            <a:fld id="{73C8753E-5E29-4F5A-8447-AC49EA0A53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19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73992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10C5-8144-458C-99FB-0D0EBF84198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6153-D410-4AEE-9CDC-DE83F17EFE80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8BC5-70FA-4424-84DD-5ECF8F0190AF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9F9D97-7AB9-4D0C-A30C-C72FF24D496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B97B0-2ED9-4B04-B7BA-A396D3B218D8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C45D-D7A0-4C45-BCD7-51B9D1EC4670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3569E7-30ED-4111-9DE5-232990FD1521}" type="datetime1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1BD2B-C896-4CE5-9072-7ABE3A3029A9}" type="datetime1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17C8E-737E-4198-B857-00185F1C25DA}" type="datetime1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CFBFE-A034-4BE5-9F46-66935E132023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65F5-C15D-472B-A2E8-FA919C644EA5}" type="datetime1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E046D-0188-40C4-97EB-0FE798003F37}" type="datetime1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it-IT"/>
              <a:t>Anna Pasetto manuscrip figures (1)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A8D443D1-6AF3-4C73-B2B8-B11A2BF2F1A1}"/>
              </a:ext>
            </a:extLst>
          </p:cNvPr>
          <p:cNvSpPr txBox="1"/>
          <p:nvPr/>
        </p:nvSpPr>
        <p:spPr>
          <a:xfrm>
            <a:off x="5733941" y="89200"/>
            <a:ext cx="109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-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C847CD-A99B-4C8D-BFBF-AA0315FCD92C}"/>
              </a:ext>
            </a:extLst>
          </p:cNvPr>
          <p:cNvSpPr txBox="1"/>
          <p:nvPr/>
        </p:nvSpPr>
        <p:spPr>
          <a:xfrm>
            <a:off x="175341" y="76200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graphicFrame>
        <p:nvGraphicFramePr>
          <p:cNvPr id="22" name="Table 4">
            <a:extLst>
              <a:ext uri="{FF2B5EF4-FFF2-40B4-BE49-F238E27FC236}">
                <a16:creationId xmlns:a16="http://schemas.microsoft.com/office/drawing/2014/main" id="{BF4634B0-93F5-1F40-8939-D78A190781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7502497"/>
              </p:ext>
            </p:extLst>
          </p:nvPr>
        </p:nvGraphicFramePr>
        <p:xfrm>
          <a:off x="127856" y="383579"/>
          <a:ext cx="6678822" cy="230557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47430">
                  <a:extLst>
                    <a:ext uri="{9D8B030D-6E8A-4147-A177-3AD203B41FA5}">
                      <a16:colId xmlns:a16="http://schemas.microsoft.com/office/drawing/2014/main" val="476842394"/>
                    </a:ext>
                  </a:extLst>
                </a:gridCol>
                <a:gridCol w="469226">
                  <a:extLst>
                    <a:ext uri="{9D8B030D-6E8A-4147-A177-3AD203B41FA5}">
                      <a16:colId xmlns:a16="http://schemas.microsoft.com/office/drawing/2014/main" val="433695407"/>
                    </a:ext>
                  </a:extLst>
                </a:gridCol>
                <a:gridCol w="469226">
                  <a:extLst>
                    <a:ext uri="{9D8B030D-6E8A-4147-A177-3AD203B41FA5}">
                      <a16:colId xmlns:a16="http://schemas.microsoft.com/office/drawing/2014/main" val="784985152"/>
                    </a:ext>
                  </a:extLst>
                </a:gridCol>
                <a:gridCol w="8602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0247">
                  <a:extLst>
                    <a:ext uri="{9D8B030D-6E8A-4147-A177-3AD203B41FA5}">
                      <a16:colId xmlns:a16="http://schemas.microsoft.com/office/drawing/2014/main" val="4094943513"/>
                    </a:ext>
                  </a:extLst>
                </a:gridCol>
                <a:gridCol w="878233">
                  <a:extLst>
                    <a:ext uri="{9D8B030D-6E8A-4147-A177-3AD203B41FA5}">
                      <a16:colId xmlns:a16="http://schemas.microsoft.com/office/drawing/2014/main" val="1491197802"/>
                    </a:ext>
                  </a:extLst>
                </a:gridCol>
                <a:gridCol w="912821">
                  <a:extLst>
                    <a:ext uri="{9D8B030D-6E8A-4147-A177-3AD203B41FA5}">
                      <a16:colId xmlns:a16="http://schemas.microsoft.com/office/drawing/2014/main" val="1996663598"/>
                    </a:ext>
                  </a:extLst>
                </a:gridCol>
                <a:gridCol w="793771">
                  <a:extLst>
                    <a:ext uri="{9D8B030D-6E8A-4147-A177-3AD203B41FA5}">
                      <a16:colId xmlns:a16="http://schemas.microsoft.com/office/drawing/2014/main" val="1091571014"/>
                    </a:ext>
                  </a:extLst>
                </a:gridCol>
                <a:gridCol w="887621">
                  <a:extLst>
                    <a:ext uri="{9D8B030D-6E8A-4147-A177-3AD203B41FA5}">
                      <a16:colId xmlns:a16="http://schemas.microsoft.com/office/drawing/2014/main" val="30595424"/>
                    </a:ext>
                  </a:extLst>
                </a:gridCol>
              </a:tblGrid>
              <a:tr h="969933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Pt. ID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+mj-lt"/>
                          <a:cs typeface="Arial" pitchFamily="34" charset="0"/>
                        </a:rPr>
                        <a:t>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+mj-lt"/>
                          <a:cs typeface="Arial" pitchFamily="34" charset="0"/>
                        </a:rPr>
                        <a:t>Se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Tumor</a:t>
                      </a:r>
                      <a:r>
                        <a:rPr lang="en-US" sz="1100" b="1" baseline="0" dirty="0">
                          <a:latin typeface="+mj-lt"/>
                        </a:rPr>
                        <a:t> type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Cell sources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latin typeface="+mj-lt"/>
                        </a:rPr>
                        <a:t>Clonality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iPSC lines established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Different TCR identified in iPSC clones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Tumor</a:t>
                      </a:r>
                    </a:p>
                    <a:p>
                      <a:pPr algn="ctr"/>
                      <a:r>
                        <a:rPr lang="en-US" sz="1100" b="1" dirty="0">
                          <a:latin typeface="+mj-lt"/>
                        </a:rPr>
                        <a:t> reactive TCR identified in iPSC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+mj-lt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5215"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406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5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</a:rPr>
                        <a:t>Pancreatic</a:t>
                      </a:r>
                      <a:endParaRPr lang="en-US" sz="1100" b="0" i="0" u="none" strike="noStrike" kern="1200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Infusion Ba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Mostly monoclon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9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42560379"/>
                  </a:ext>
                </a:extLst>
              </a:tr>
              <a:tr h="445215"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1913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4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Melanoma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Fragment Culture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Polyclonal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221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9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3</a:t>
                      </a:r>
                      <a:r>
                        <a:rPr lang="en-US" sz="1100" b="0" i="0" u="none" strike="noStrike" kern="1200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+mn-lt"/>
                          <a:ea typeface="+mn-ea"/>
                          <a:cs typeface="Arial" pitchFamily="34" charset="0"/>
                          <a:sym typeface="Calibri"/>
                        </a:rPr>
                        <a:t>+ (1 new)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1219632"/>
                  </a:ext>
                </a:extLst>
              </a:tr>
              <a:tr h="445215"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3784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dk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Melanoma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Fragment Culture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Polyclonal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178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u="none" strike="noStrike" cap="none" spc="0" baseline="0" dirty="0">
                          <a:ln>
                            <a:noFill/>
                          </a:ln>
                          <a:uFillTx/>
                          <a:latin typeface="+mj-lt"/>
                          <a:sym typeface="Calibri"/>
                        </a:rPr>
                        <a:t>25</a:t>
                      </a:r>
                      <a:endParaRPr lang="en-US" sz="1100" b="0" i="0" u="none" strike="noStrike" cap="none" spc="0" baseline="0" dirty="0">
                        <a:ln>
                          <a:noFill/>
                        </a:ln>
                        <a:solidFill>
                          <a:schemeClr val="dk1"/>
                        </a:solidFill>
                        <a:uFillTx/>
                        <a:latin typeface="+mj-lt"/>
                        <a:ea typeface="+mn-ea"/>
                        <a:cs typeface="Arial" pitchFamily="34" charset="0"/>
                        <a:sym typeface="Calibri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latinLnBrk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100" b="0" i="0" u="none" strike="noStrike" cap="none" spc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uFillTx/>
                          <a:latin typeface="+mj-lt"/>
                          <a:ea typeface="+mn-ea"/>
                          <a:cs typeface="Arial" pitchFamily="34" charset="0"/>
                          <a:sym typeface="Calibri"/>
                        </a:rPr>
                        <a:t>1 + (3 new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67069286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DC76FB41-0C7E-2B8C-D880-C46B33DE2CF6}"/>
              </a:ext>
            </a:extLst>
          </p:cNvPr>
          <p:cNvGrpSpPr/>
          <p:nvPr/>
        </p:nvGrpSpPr>
        <p:grpSpPr>
          <a:xfrm>
            <a:off x="224466" y="2727929"/>
            <a:ext cx="6384523" cy="3313341"/>
            <a:chOff x="16276" y="3262112"/>
            <a:chExt cx="6384523" cy="3313341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38BFD69-F311-B747-82C7-A044FE62255D}"/>
                </a:ext>
              </a:extLst>
            </p:cNvPr>
            <p:cNvSpPr txBox="1"/>
            <p:nvPr/>
          </p:nvSpPr>
          <p:spPr>
            <a:xfrm>
              <a:off x="16276" y="3262112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5B150148-ABAB-F443-B44A-1A7368A98488}"/>
                </a:ext>
              </a:extLst>
            </p:cNvPr>
            <p:cNvCxnSpPr/>
            <p:nvPr/>
          </p:nvCxnSpPr>
          <p:spPr>
            <a:xfrm>
              <a:off x="2248067" y="5148648"/>
              <a:ext cx="0" cy="381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D11436E6-147A-B44C-9087-2D36133ACCB0}"/>
                </a:ext>
              </a:extLst>
            </p:cNvPr>
            <p:cNvCxnSpPr/>
            <p:nvPr/>
          </p:nvCxnSpPr>
          <p:spPr>
            <a:xfrm>
              <a:off x="3162467" y="5148648"/>
              <a:ext cx="0" cy="381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EA5C504-514C-9B4C-B273-490BD3A230DD}"/>
                </a:ext>
              </a:extLst>
            </p:cNvPr>
            <p:cNvSpPr txBox="1"/>
            <p:nvPr/>
          </p:nvSpPr>
          <p:spPr>
            <a:xfrm>
              <a:off x="1714667" y="6313843"/>
              <a:ext cx="308289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TCR immunoseq analysis of Vβ from genomic DNA 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4A1F27E-9694-7742-A27E-34BAC59D804C}"/>
                </a:ext>
              </a:extLst>
            </p:cNvPr>
            <p:cNvGrpSpPr/>
            <p:nvPr/>
          </p:nvGrpSpPr>
          <p:grpSpPr>
            <a:xfrm>
              <a:off x="1858749" y="5561845"/>
              <a:ext cx="778635" cy="614869"/>
              <a:chOff x="1820482" y="7880797"/>
              <a:chExt cx="778635" cy="614869"/>
            </a:xfrm>
          </p:grpSpPr>
          <p:pic>
            <p:nvPicPr>
              <p:cNvPr id="16" name="Picture 15" descr="Diagram&#10;&#10;Description automatically generated">
                <a:extLst>
                  <a:ext uri="{FF2B5EF4-FFF2-40B4-BE49-F238E27FC236}">
                    <a16:creationId xmlns:a16="http://schemas.microsoft.com/office/drawing/2014/main" id="{24EA688C-5C2E-F140-A263-0830F4A2AF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950" t="13296" r="23881" b="46729"/>
              <a:stretch/>
            </p:blipFill>
            <p:spPr>
              <a:xfrm>
                <a:off x="1820482" y="7880797"/>
                <a:ext cx="778635" cy="614869"/>
              </a:xfrm>
              <a:prstGeom prst="rect">
                <a:avLst/>
              </a:prstGeom>
            </p:spPr>
          </p:pic>
          <p:sp>
            <p:nvSpPr>
              <p:cNvPr id="6" name="Frame 5">
                <a:extLst>
                  <a:ext uri="{FF2B5EF4-FFF2-40B4-BE49-F238E27FC236}">
                    <a16:creationId xmlns:a16="http://schemas.microsoft.com/office/drawing/2014/main" id="{DD198206-AAB9-AC44-966E-15189B969C05}"/>
                  </a:ext>
                </a:extLst>
              </p:cNvPr>
              <p:cNvSpPr/>
              <p:nvPr/>
            </p:nvSpPr>
            <p:spPr>
              <a:xfrm>
                <a:off x="1828800" y="8077200"/>
                <a:ext cx="76200" cy="83820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6CC6F591-8C61-4540-B55D-2F16782EF629}"/>
                </a:ext>
              </a:extLst>
            </p:cNvPr>
            <p:cNvGrpSpPr/>
            <p:nvPr/>
          </p:nvGrpSpPr>
          <p:grpSpPr>
            <a:xfrm>
              <a:off x="2776256" y="5561844"/>
              <a:ext cx="778635" cy="614869"/>
              <a:chOff x="1820482" y="7880797"/>
              <a:chExt cx="778635" cy="614869"/>
            </a:xfrm>
          </p:grpSpPr>
          <p:pic>
            <p:nvPicPr>
              <p:cNvPr id="20" name="Picture 19" descr="Diagram&#10;&#10;Description automatically generated">
                <a:extLst>
                  <a:ext uri="{FF2B5EF4-FFF2-40B4-BE49-F238E27FC236}">
                    <a16:creationId xmlns:a16="http://schemas.microsoft.com/office/drawing/2014/main" id="{E50D9B31-72AE-A843-98B8-FC4C0EEA3E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950" t="13296" r="23881" b="46729"/>
              <a:stretch/>
            </p:blipFill>
            <p:spPr>
              <a:xfrm>
                <a:off x="1820482" y="7880797"/>
                <a:ext cx="778635" cy="614869"/>
              </a:xfrm>
              <a:prstGeom prst="rect">
                <a:avLst/>
              </a:prstGeom>
            </p:spPr>
          </p:pic>
          <p:sp>
            <p:nvSpPr>
              <p:cNvPr id="21" name="Frame 20">
                <a:extLst>
                  <a:ext uri="{FF2B5EF4-FFF2-40B4-BE49-F238E27FC236}">
                    <a16:creationId xmlns:a16="http://schemas.microsoft.com/office/drawing/2014/main" id="{8A6B0E59-D561-7940-AD50-2FEEC3A5294A}"/>
                  </a:ext>
                </a:extLst>
              </p:cNvPr>
              <p:cNvSpPr/>
              <p:nvPr/>
            </p:nvSpPr>
            <p:spPr>
              <a:xfrm>
                <a:off x="1828800" y="8077200"/>
                <a:ext cx="76200" cy="83820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pic>
          <p:nvPicPr>
            <p:cNvPr id="12" name="Picture 11" descr="Chart, diagram&#10;&#10;Description automatically generated with medium confidence">
              <a:extLst>
                <a:ext uri="{FF2B5EF4-FFF2-40B4-BE49-F238E27FC236}">
                  <a16:creationId xmlns:a16="http://schemas.microsoft.com/office/drawing/2014/main" id="{ABFCCE6D-47CB-A641-60C3-42C87EE5A3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122" y="3429000"/>
              <a:ext cx="5925677" cy="1862333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BEC0913-00AF-5944-B5A3-777BBE1E758D}"/>
                </a:ext>
              </a:extLst>
            </p:cNvPr>
            <p:cNvSpPr txBox="1"/>
            <p:nvPr/>
          </p:nvSpPr>
          <p:spPr>
            <a:xfrm>
              <a:off x="3276600" y="3429000"/>
              <a:ext cx="914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Several selected TIL-iPSC clones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CF36097-33F7-7B68-04D5-96031A58917B}"/>
              </a:ext>
            </a:extLst>
          </p:cNvPr>
          <p:cNvSpPr txBox="1"/>
          <p:nvPr/>
        </p:nvSpPr>
        <p:spPr>
          <a:xfrm>
            <a:off x="127856" y="5995104"/>
            <a:ext cx="6577744" cy="20940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: A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mmary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ble of the patient samples used and the schema of the stud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228600" marR="0" indent="-22860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AutoNum type="alphaUcParenBoth"/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 summary table of the three patient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L samples used for reprogramming experiments. Patient ID, age, sex, cancer type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arting cell sourc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clonality of T cells, numbers of iPSC colonies generated, numbers of total TCRs obtained from each patient and numbers of tumor reactive TCRs obtained in iPSC clones are shown. Infusion bag means TIL 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xpanded for TIL therapy and fragment culture means TIL cultured for limited time (13-16 days). Please see the method section for the detail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2090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1A4A585-D978-D265-796D-48B1E04F6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</a:t>
            </a:fld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6C3AF8-1F2D-562F-F4B3-B704FB5CBC2C}"/>
              </a:ext>
            </a:extLst>
          </p:cNvPr>
          <p:cNvSpPr txBox="1"/>
          <p:nvPr/>
        </p:nvSpPr>
        <p:spPr>
          <a:xfrm>
            <a:off x="228600" y="304800"/>
            <a:ext cx="6526037" cy="31097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 A schematic representation of TCR sequencing of TIL-iPSCs. Briefly, each dish of TIL-iPSC colonies were picked up as clones as many as possible into each well of culture plates, expanded, passaged up to three times and frozen down for further experiments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fore freezing about 15-20 individual iPSC lines, about 1E+5 cells each were pooled together into a tube called master tube and genomic DNA was extracted for TCR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quencing. After picking up the colonies, all the remaining iPSC colonies (approximately 600-900 iPSC colonies) were collected in a tube for genomic DNA extraction and TCR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mmunoseq analysis (mother tube).  For testing the reactivity of TCRs identified in TIL-iPSC master tubes, individual iPSCs were re-submitted for TCR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quencing, cloned into gamma retrovirus vector (pMSGV1), transduced into healthy donor PBL, and tested for the reactivity against patient’s tumor cells by cytotoxic assay, 4-1BB upregulation assay and IFNγ production assay by ELISA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793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855</TotalTime>
  <Words>369</Words>
  <Application>Microsoft Office PowerPoint</Application>
  <PresentationFormat>On-screen Show (4:3)</PresentationFormat>
  <Paragraphs>4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Pasetto, Anna (NIH/NCI) [F]</dc:creator>
  <cp:keywords/>
  <dc:description/>
  <cp:lastModifiedBy>Islam, Rafiqul (NIH/NCI) [E]</cp:lastModifiedBy>
  <cp:revision>1444</cp:revision>
  <cp:lastPrinted>2023-02-05T19:57:40Z</cp:lastPrinted>
  <dcterms:created xsi:type="dcterms:W3CDTF">2006-08-16T00:00:00Z</dcterms:created>
  <dcterms:modified xsi:type="dcterms:W3CDTF">2023-04-29T16:46:23Z</dcterms:modified>
  <cp:category/>
</cp:coreProperties>
</file>